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  <p:sldId id="258" r:id="rId3"/>
    <p:sldId id="259" r:id="rId4"/>
    <p:sldId id="260" r:id="rId5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3"/>
    <p:restoredTop sz="94693"/>
  </p:normalViewPr>
  <p:slideViewPr>
    <p:cSldViewPr snapToGrid="0" snapToObjects="1">
      <p:cViewPr varScale="1">
        <p:scale>
          <a:sx n="78" d="100"/>
          <a:sy n="78" d="100"/>
        </p:scale>
        <p:origin x="28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061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5876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4406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8982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6868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819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418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9488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418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390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154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F58BF7-F47B-3C44-8CD3-E4EB4606D127}" type="datetimeFigureOut">
              <a:rPr lang="en-US" smtClean="0"/>
              <a:t>8/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7DD209-AEB0-2049-922F-A7293DB14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983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tif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35402" y="367413"/>
            <a:ext cx="5578997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ource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le 1A associated with Figure 3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kx2.2</a:t>
            </a:r>
            <a:r>
              <a:rPr lang="en-US" sz="1200" baseline="30000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endo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Nkx2.2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E15.5 RNA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: Genes showing significant differential expression in both Nkx2.2</a:t>
            </a:r>
            <a:r>
              <a:rPr lang="en-US" sz="1200" baseline="30000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endo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Nkx2.2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mice (120 genes).</a:t>
            </a:r>
          </a:p>
          <a:p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ge 1 of 4</a:t>
            </a:r>
            <a:endParaRPr lang="en-US" sz="1200" dirty="0"/>
          </a:p>
        </p:txBody>
      </p:sp>
      <p:pic>
        <p:nvPicPr>
          <p:cNvPr id="3" name="Picture 3" descr="C:\Users\Angela\Documents\NYC\Sussel Lab\EPKO\EPKO Paper Figures\Supp Table 2_Page_1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03" t="7598" r="51136" b="8334"/>
          <a:stretch/>
        </p:blipFill>
        <p:spPr bwMode="auto">
          <a:xfrm>
            <a:off x="1234151" y="1685081"/>
            <a:ext cx="4381500" cy="6534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516093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:\Users\Angela\Documents\NYC\Sussel Lab\EPKO\EPKO Paper Figures\Supp Table 2_Page_2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92" t="7108" r="51894" b="8824"/>
          <a:stretch/>
        </p:blipFill>
        <p:spPr bwMode="auto">
          <a:xfrm>
            <a:off x="1254160" y="1847127"/>
            <a:ext cx="4286250" cy="6534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635402" y="367413"/>
            <a:ext cx="5578997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ource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le 1A associated with Figure 3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kx2.2</a:t>
            </a:r>
            <a:r>
              <a:rPr lang="en-US" sz="1200" baseline="30000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endo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Nkx2.2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E15.5 RNA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: Genes showing significant differential expression in both Nkx2.2</a:t>
            </a:r>
            <a:r>
              <a:rPr lang="en-US" sz="1200" baseline="30000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endo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Nkx2.2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mice (120 genes).</a:t>
            </a:r>
          </a:p>
          <a:p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ge 2 of 4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00903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 descr="C:\Users\Angela\Documents\NYC\Sussel Lab\EPKO\EPKO Paper Figures\Supp Table 2_Page_3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93" t="7598" r="51326" b="9314"/>
          <a:stretch/>
        </p:blipFill>
        <p:spPr bwMode="auto">
          <a:xfrm>
            <a:off x="1219200" y="1699308"/>
            <a:ext cx="4343400" cy="6457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635402" y="367413"/>
            <a:ext cx="5578997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ource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le 1A associated with 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kx2.2</a:t>
            </a:r>
            <a:r>
              <a:rPr lang="en-US" sz="1200" baseline="30000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endo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Nkx2.2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E15.5 RNA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: Genes showing significant differential expression in both Nkx2.2</a:t>
            </a:r>
            <a:r>
              <a:rPr lang="en-US" sz="1200" baseline="30000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endo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Nkx2.2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mice (120 genes).</a:t>
            </a:r>
          </a:p>
          <a:p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ge 3 of 4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5027395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635402" y="367413"/>
            <a:ext cx="5578997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ource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le 1A associated with 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kx2.2</a:t>
            </a:r>
            <a:r>
              <a:rPr lang="en-US" sz="1200" baseline="30000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endo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Nkx2.2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E15.5 RNA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: Genes showing significant differential expression in both Nkx2.2</a:t>
            </a:r>
            <a:r>
              <a:rPr lang="en-US" sz="1200" baseline="30000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endo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Nkx2.2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mice (120 genes).</a:t>
            </a:r>
          </a:p>
          <a:p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ge 4 of 4</a:t>
            </a:r>
            <a:endParaRPr lang="en-US" sz="1200" dirty="0"/>
          </a:p>
        </p:txBody>
      </p:sp>
      <p:pic>
        <p:nvPicPr>
          <p:cNvPr id="6" name="Picture 2" descr="C:\Users\Angela\Documents\NYC\Sussel Lab\EPKO\EPKO Paper Figures\Supp Table 2_Page_4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41" t="7843" r="51515" b="42647"/>
          <a:stretch/>
        </p:blipFill>
        <p:spPr bwMode="auto">
          <a:xfrm>
            <a:off x="1285240" y="1918503"/>
            <a:ext cx="4279320" cy="3848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42462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32</Words>
  <Application>Microsoft Macintosh PowerPoint</Application>
  <PresentationFormat>Letter Paper (8.5x11 in)</PresentationFormat>
  <Paragraphs>1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Calibri</vt:lpstr>
      <vt:lpstr>Calibri Light</vt:lpstr>
      <vt:lpstr>Symbol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2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3</cp:revision>
  <dcterms:created xsi:type="dcterms:W3CDTF">2016-08-03T22:46:02Z</dcterms:created>
  <dcterms:modified xsi:type="dcterms:W3CDTF">2016-08-04T16:49:10Z</dcterms:modified>
</cp:coreProperties>
</file>